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35" d="100"/>
          <a:sy n="35" d="100"/>
        </p:scale>
        <p:origin x="-1200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ENG\SkyDrive\Fine%20mapping%20and%20cytoplasmic%20analysis\11-7-2012\11-7%20%202006,%202008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bar"/>
        <c:grouping val="clustered"/>
        <c:varyColors val="0"/>
        <c:ser>
          <c:idx val="0"/>
          <c:order val="0"/>
          <c:invertIfNegative val="0"/>
          <c:cat>
            <c:strRef>
              <c:f>穗重!$A$3:$A$32</c:f>
              <c:strCache>
                <c:ptCount val="30"/>
                <c:pt idx="0">
                  <c:v>A1/R1</c:v>
                </c:pt>
                <c:pt idx="1">
                  <c:v>A2/R1</c:v>
                </c:pt>
                <c:pt idx="2">
                  <c:v>A3/R1</c:v>
                </c:pt>
                <c:pt idx="3">
                  <c:v>A4/R1</c:v>
                </c:pt>
                <c:pt idx="4">
                  <c:v>A5/R1</c:v>
                </c:pt>
                <c:pt idx="5">
                  <c:v>A6/R1</c:v>
                </c:pt>
                <c:pt idx="6">
                  <c:v>A1/R2</c:v>
                </c:pt>
                <c:pt idx="7">
                  <c:v>A2/R2</c:v>
                </c:pt>
                <c:pt idx="8">
                  <c:v>A3/R2</c:v>
                </c:pt>
                <c:pt idx="9">
                  <c:v>A4/R2</c:v>
                </c:pt>
                <c:pt idx="10">
                  <c:v>A5/R2</c:v>
                </c:pt>
                <c:pt idx="11">
                  <c:v>A6/R2</c:v>
                </c:pt>
                <c:pt idx="12">
                  <c:v>A1/R3</c:v>
                </c:pt>
                <c:pt idx="13">
                  <c:v>A2/R3</c:v>
                </c:pt>
                <c:pt idx="14">
                  <c:v>A3/R3</c:v>
                </c:pt>
                <c:pt idx="15">
                  <c:v>A4/R3</c:v>
                </c:pt>
                <c:pt idx="16">
                  <c:v>A5/R3</c:v>
                </c:pt>
                <c:pt idx="17">
                  <c:v>A6/R3</c:v>
                </c:pt>
                <c:pt idx="18">
                  <c:v>A1/R4</c:v>
                </c:pt>
                <c:pt idx="19">
                  <c:v>A2/R4</c:v>
                </c:pt>
                <c:pt idx="20">
                  <c:v>A3/R4</c:v>
                </c:pt>
                <c:pt idx="21">
                  <c:v>A4/R4</c:v>
                </c:pt>
                <c:pt idx="22">
                  <c:v>A5/R4</c:v>
                </c:pt>
                <c:pt idx="23">
                  <c:v>A6/R4</c:v>
                </c:pt>
                <c:pt idx="24">
                  <c:v>A1/R5</c:v>
                </c:pt>
                <c:pt idx="25">
                  <c:v>A2/R5</c:v>
                </c:pt>
                <c:pt idx="26">
                  <c:v>A3/R5</c:v>
                </c:pt>
                <c:pt idx="27">
                  <c:v>A4/R5</c:v>
                </c:pt>
                <c:pt idx="28">
                  <c:v>A5/R5</c:v>
                </c:pt>
                <c:pt idx="29">
                  <c:v>A6/R5</c:v>
                </c:pt>
              </c:strCache>
            </c:strRef>
          </c:cat>
          <c:val>
            <c:numRef>
              <c:f>穗重!$E$3:$E$32</c:f>
              <c:numCache>
                <c:formatCode>0.00</c:formatCode>
                <c:ptCount val="30"/>
                <c:pt idx="0">
                  <c:v>3.9733280699266991</c:v>
                </c:pt>
                <c:pt idx="1">
                  <c:v>3.6334486129349091</c:v>
                </c:pt>
                <c:pt idx="2">
                  <c:v>3.9130890451610933</c:v>
                </c:pt>
                <c:pt idx="3">
                  <c:v>3.7637957957935555</c:v>
                </c:pt>
                <c:pt idx="4">
                  <c:v>3.5119878418426644</c:v>
                </c:pt>
                <c:pt idx="5">
                  <c:v>3.7312364794579227</c:v>
                </c:pt>
                <c:pt idx="6">
                  <c:v>3.316046771222076</c:v>
                </c:pt>
                <c:pt idx="7">
                  <c:v>3.0982841520581386</c:v>
                </c:pt>
                <c:pt idx="8">
                  <c:v>3.0767827862831525</c:v>
                </c:pt>
                <c:pt idx="9">
                  <c:v>3.0649836601796365</c:v>
                </c:pt>
                <c:pt idx="10">
                  <c:v>3.299744408109337</c:v>
                </c:pt>
                <c:pt idx="11">
                  <c:v>3.0744691692220756</c:v>
                </c:pt>
                <c:pt idx="12">
                  <c:v>3.0816410797746006</c:v>
                </c:pt>
                <c:pt idx="13">
                  <c:v>3.0053577087771104</c:v>
                </c:pt>
                <c:pt idx="14">
                  <c:v>3.1826197683403863</c:v>
                </c:pt>
                <c:pt idx="15">
                  <c:v>3.1481436888230365</c:v>
                </c:pt>
                <c:pt idx="16">
                  <c:v>2.9922295740059863</c:v>
                </c:pt>
                <c:pt idx="17">
                  <c:v>3.0810159669319419</c:v>
                </c:pt>
                <c:pt idx="18">
                  <c:v>3.5855523601238333</c:v>
                </c:pt>
                <c:pt idx="19">
                  <c:v>3.4331604021541282</c:v>
                </c:pt>
                <c:pt idx="20">
                  <c:v>3.1706089424198134</c:v>
                </c:pt>
                <c:pt idx="21">
                  <c:v>3.4934400552909004</c:v>
                </c:pt>
                <c:pt idx="22">
                  <c:v>3.2000538234727407</c:v>
                </c:pt>
                <c:pt idx="23">
                  <c:v>3.1567625378396307</c:v>
                </c:pt>
                <c:pt idx="24">
                  <c:v>3.7264974042951615</c:v>
                </c:pt>
                <c:pt idx="25">
                  <c:v>3.7482534575304229</c:v>
                </c:pt>
                <c:pt idx="26">
                  <c:v>3.3924082561096398</c:v>
                </c:pt>
                <c:pt idx="27">
                  <c:v>3.6470760629566432</c:v>
                </c:pt>
                <c:pt idx="28">
                  <c:v>3.8165768161633018</c:v>
                </c:pt>
                <c:pt idx="29">
                  <c:v>3.5802523032031286</c:v>
                </c:pt>
              </c:numCache>
            </c:numRef>
          </c:val>
        </c:ser>
        <c:ser>
          <c:idx val="1"/>
          <c:order val="1"/>
          <c:invertIfNegative val="0"/>
          <c:cat>
            <c:strRef>
              <c:f>穗重!$A$3:$A$32</c:f>
              <c:strCache>
                <c:ptCount val="30"/>
                <c:pt idx="0">
                  <c:v>A1/R1</c:v>
                </c:pt>
                <c:pt idx="1">
                  <c:v>A2/R1</c:v>
                </c:pt>
                <c:pt idx="2">
                  <c:v>A3/R1</c:v>
                </c:pt>
                <c:pt idx="3">
                  <c:v>A4/R1</c:v>
                </c:pt>
                <c:pt idx="4">
                  <c:v>A5/R1</c:v>
                </c:pt>
                <c:pt idx="5">
                  <c:v>A6/R1</c:v>
                </c:pt>
                <c:pt idx="6">
                  <c:v>A1/R2</c:v>
                </c:pt>
                <c:pt idx="7">
                  <c:v>A2/R2</c:v>
                </c:pt>
                <c:pt idx="8">
                  <c:v>A3/R2</c:v>
                </c:pt>
                <c:pt idx="9">
                  <c:v>A4/R2</c:v>
                </c:pt>
                <c:pt idx="10">
                  <c:v>A5/R2</c:v>
                </c:pt>
                <c:pt idx="11">
                  <c:v>A6/R2</c:v>
                </c:pt>
                <c:pt idx="12">
                  <c:v>A1/R3</c:v>
                </c:pt>
                <c:pt idx="13">
                  <c:v>A2/R3</c:v>
                </c:pt>
                <c:pt idx="14">
                  <c:v>A3/R3</c:v>
                </c:pt>
                <c:pt idx="15">
                  <c:v>A4/R3</c:v>
                </c:pt>
                <c:pt idx="16">
                  <c:v>A5/R3</c:v>
                </c:pt>
                <c:pt idx="17">
                  <c:v>A6/R3</c:v>
                </c:pt>
                <c:pt idx="18">
                  <c:v>A1/R4</c:v>
                </c:pt>
                <c:pt idx="19">
                  <c:v>A2/R4</c:v>
                </c:pt>
                <c:pt idx="20">
                  <c:v>A3/R4</c:v>
                </c:pt>
                <c:pt idx="21">
                  <c:v>A4/R4</c:v>
                </c:pt>
                <c:pt idx="22">
                  <c:v>A5/R4</c:v>
                </c:pt>
                <c:pt idx="23">
                  <c:v>A6/R4</c:v>
                </c:pt>
                <c:pt idx="24">
                  <c:v>A1/R5</c:v>
                </c:pt>
                <c:pt idx="25">
                  <c:v>A2/R5</c:v>
                </c:pt>
                <c:pt idx="26">
                  <c:v>A3/R5</c:v>
                </c:pt>
                <c:pt idx="27">
                  <c:v>A4/R5</c:v>
                </c:pt>
                <c:pt idx="28">
                  <c:v>A5/R5</c:v>
                </c:pt>
                <c:pt idx="29">
                  <c:v>A6/R5</c:v>
                </c:pt>
              </c:strCache>
            </c:strRef>
          </c:cat>
          <c:val>
            <c:numRef>
              <c:f>穗重!$O$3:$O$32</c:f>
              <c:numCache>
                <c:formatCode>General</c:formatCode>
                <c:ptCount val="30"/>
                <c:pt idx="0">
                  <c:v>4.0146933503258575</c:v>
                </c:pt>
                <c:pt idx="1">
                  <c:v>3.7157916126638857</c:v>
                </c:pt>
                <c:pt idx="2">
                  <c:v>4.0663086954763328</c:v>
                </c:pt>
                <c:pt idx="3">
                  <c:v>3.9112169884967636</c:v>
                </c:pt>
                <c:pt idx="4">
                  <c:v>3.5944593340793496</c:v>
                </c:pt>
                <c:pt idx="5">
                  <c:v>3.947392238111529</c:v>
                </c:pt>
                <c:pt idx="6">
                  <c:v>3.4639471250468223</c:v>
                </c:pt>
                <c:pt idx="7">
                  <c:v>3.267260679887555</c:v>
                </c:pt>
                <c:pt idx="8">
                  <c:v>3.3237983716265598</c:v>
                </c:pt>
                <c:pt idx="9">
                  <c:v>3.119404092328331</c:v>
                </c:pt>
                <c:pt idx="10">
                  <c:v>3.5218548087342576</c:v>
                </c:pt>
                <c:pt idx="11">
                  <c:v>3.1175499223525556</c:v>
                </c:pt>
                <c:pt idx="12">
                  <c:v>3.2103849226658485</c:v>
                </c:pt>
                <c:pt idx="13">
                  <c:v>3.1932726624062191</c:v>
                </c:pt>
                <c:pt idx="14">
                  <c:v>3.2748673465071438</c:v>
                </c:pt>
                <c:pt idx="15">
                  <c:v>3.141955765277165</c:v>
                </c:pt>
                <c:pt idx="16">
                  <c:v>3.101067300236291</c:v>
                </c:pt>
                <c:pt idx="17">
                  <c:v>3.1826008566894313</c:v>
                </c:pt>
                <c:pt idx="18">
                  <c:v>3.6195916148872875</c:v>
                </c:pt>
                <c:pt idx="19">
                  <c:v>3.6562840178409748</c:v>
                </c:pt>
                <c:pt idx="20">
                  <c:v>3.182030161419545</c:v>
                </c:pt>
                <c:pt idx="21">
                  <c:v>3.529880183473884</c:v>
                </c:pt>
                <c:pt idx="22">
                  <c:v>3.2092765891524366</c:v>
                </c:pt>
                <c:pt idx="23">
                  <c:v>3.1843256960661415</c:v>
                </c:pt>
                <c:pt idx="24">
                  <c:v>3.8283883720926677</c:v>
                </c:pt>
                <c:pt idx="25">
                  <c:v>3.7373968344464559</c:v>
                </c:pt>
                <c:pt idx="26">
                  <c:v>3.6268212456665148</c:v>
                </c:pt>
                <c:pt idx="27">
                  <c:v>3.8291853819928163</c:v>
                </c:pt>
                <c:pt idx="28">
                  <c:v>4.0670689936222191</c:v>
                </c:pt>
                <c:pt idx="29">
                  <c:v>3.738329040512575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57677312"/>
        <c:axId val="357769216"/>
      </c:barChart>
      <c:catAx>
        <c:axId val="357677312"/>
        <c:scaling>
          <c:orientation val="minMax"/>
        </c:scaling>
        <c:delete val="0"/>
        <c:axPos val="l"/>
        <c:majorTickMark val="out"/>
        <c:minorTickMark val="none"/>
        <c:tickLblPos val="nextTo"/>
        <c:crossAx val="357769216"/>
        <c:crosses val="autoZero"/>
        <c:auto val="1"/>
        <c:lblAlgn val="ctr"/>
        <c:lblOffset val="100"/>
        <c:noMultiLvlLbl val="0"/>
      </c:catAx>
      <c:valAx>
        <c:axId val="357769216"/>
        <c:scaling>
          <c:orientation val="minMax"/>
        </c:scaling>
        <c:delete val="0"/>
        <c:axPos val="b"/>
        <c:numFmt formatCode="0.00" sourceLinked="1"/>
        <c:majorTickMark val="out"/>
        <c:minorTickMark val="none"/>
        <c:tickLblPos val="nextTo"/>
        <c:crossAx val="35767731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4660802"/>
              </p:ext>
            </p:extLst>
          </p:nvPr>
        </p:nvGraphicFramePr>
        <p:xfrm>
          <a:off x="381000" y="381000"/>
          <a:ext cx="5181600" cy="8229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ctangle 2"/>
          <p:cNvSpPr/>
          <p:nvPr/>
        </p:nvSpPr>
        <p:spPr>
          <a:xfrm>
            <a:off x="2209800" y="8686800"/>
            <a:ext cx="22866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W</a:t>
            </a:r>
            <a:r>
              <a:rPr lang="en-US" b="1" dirty="0" smtClean="0"/>
              <a:t>eight </a:t>
            </a:r>
            <a:r>
              <a:rPr lang="en-US" b="1" dirty="0"/>
              <a:t>per </a:t>
            </a:r>
            <a:r>
              <a:rPr lang="en-US" b="1" dirty="0" smtClean="0"/>
              <a:t>panicle (g)</a:t>
            </a:r>
            <a:endParaRPr lang="en-US" b="1" dirty="0"/>
          </a:p>
        </p:txBody>
      </p:sp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66932" y="8741371"/>
            <a:ext cx="465085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6286" y="0"/>
            <a:ext cx="13314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Figure S8</a:t>
            </a:r>
            <a:endParaRPr lang="en-US" sz="20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5181600" y="183113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39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59</a:t>
            </a:r>
            <a:endParaRPr lang="en-US" sz="800" spc="-10" dirty="0"/>
          </a:p>
        </p:txBody>
      </p:sp>
      <p:sp>
        <p:nvSpPr>
          <p:cNvPr id="7" name="TextBox 6"/>
          <p:cNvSpPr txBox="1"/>
          <p:nvPr/>
        </p:nvSpPr>
        <p:spPr>
          <a:xfrm>
            <a:off x="5181600" y="53340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0</a:t>
            </a:r>
            <a:r>
              <a:rPr lang="en-US" altLang="zh-CN" sz="800" spc="-10" dirty="0" smtClean="0"/>
              <a:t>.78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0</a:t>
            </a:r>
            <a:r>
              <a:rPr lang="en-US" altLang="zh-CN" sz="800" spc="-10" dirty="0" smtClean="0"/>
              <a:t>.79</a:t>
            </a:r>
            <a:endParaRPr lang="en-US" sz="800" spc="-10" dirty="0"/>
          </a:p>
        </p:txBody>
      </p:sp>
      <p:sp>
        <p:nvSpPr>
          <p:cNvPr id="8" name="TextBox 7"/>
          <p:cNvSpPr txBox="1"/>
          <p:nvPr/>
        </p:nvSpPr>
        <p:spPr>
          <a:xfrm>
            <a:off x="5181600" y="79294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29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3</a:t>
            </a:r>
            <a:r>
              <a:rPr lang="en-US" altLang="zh-CN" sz="800" spc="-10" dirty="0" smtClean="0"/>
              <a:t>.14</a:t>
            </a:r>
            <a:endParaRPr lang="en-US" sz="800" spc="-10" dirty="0"/>
          </a:p>
        </p:txBody>
      </p:sp>
      <p:sp>
        <p:nvSpPr>
          <p:cNvPr id="9" name="TextBox 8"/>
          <p:cNvSpPr txBox="1"/>
          <p:nvPr/>
        </p:nvSpPr>
        <p:spPr>
          <a:xfrm>
            <a:off x="5181600" y="105249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09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70</a:t>
            </a:r>
            <a:endParaRPr lang="en-US" sz="800" spc="-10" dirty="0"/>
          </a:p>
        </p:txBody>
      </p:sp>
      <p:sp>
        <p:nvSpPr>
          <p:cNvPr id="10" name="TextBox 9"/>
          <p:cNvSpPr txBox="1"/>
          <p:nvPr/>
        </p:nvSpPr>
        <p:spPr>
          <a:xfrm>
            <a:off x="5181600" y="131203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53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10</a:t>
            </a:r>
            <a:endParaRPr lang="en-US" sz="800" spc="-10" dirty="0"/>
          </a:p>
        </p:txBody>
      </p:sp>
      <p:sp>
        <p:nvSpPr>
          <p:cNvPr id="11" name="TextBox 10"/>
          <p:cNvSpPr txBox="1"/>
          <p:nvPr/>
        </p:nvSpPr>
        <p:spPr>
          <a:xfrm>
            <a:off x="5181600" y="157158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22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96</a:t>
            </a:r>
            <a:endParaRPr lang="en-US" sz="800" spc="-10" dirty="0"/>
          </a:p>
        </p:txBody>
      </p:sp>
      <p:sp>
        <p:nvSpPr>
          <p:cNvPr id="12" name="TextBox 11"/>
          <p:cNvSpPr txBox="1"/>
          <p:nvPr/>
        </p:nvSpPr>
        <p:spPr>
          <a:xfrm>
            <a:off x="5181600" y="209067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12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39</a:t>
            </a:r>
            <a:endParaRPr lang="en-US" sz="800" spc="-10" dirty="0"/>
          </a:p>
        </p:txBody>
      </p:sp>
      <p:sp>
        <p:nvSpPr>
          <p:cNvPr id="13" name="TextBox 12"/>
          <p:cNvSpPr txBox="1"/>
          <p:nvPr/>
        </p:nvSpPr>
        <p:spPr>
          <a:xfrm>
            <a:off x="5181600" y="235022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4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20</a:t>
            </a:r>
            <a:endParaRPr lang="en-US" sz="800" spc="-10" dirty="0"/>
          </a:p>
        </p:txBody>
      </p:sp>
      <p:sp>
        <p:nvSpPr>
          <p:cNvPr id="14" name="TextBox 13"/>
          <p:cNvSpPr txBox="1"/>
          <p:nvPr/>
        </p:nvSpPr>
        <p:spPr>
          <a:xfrm>
            <a:off x="5181600" y="260976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1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85</a:t>
            </a:r>
            <a:endParaRPr lang="en-US" sz="800" spc="-10" dirty="0"/>
          </a:p>
        </p:txBody>
      </p:sp>
      <p:sp>
        <p:nvSpPr>
          <p:cNvPr id="15" name="TextBox 14"/>
          <p:cNvSpPr txBox="1"/>
          <p:nvPr/>
        </p:nvSpPr>
        <p:spPr>
          <a:xfrm>
            <a:off x="5181600" y="286931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99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65</a:t>
            </a:r>
            <a:endParaRPr lang="en-US" sz="800" spc="-10" dirty="0"/>
          </a:p>
        </p:txBody>
      </p:sp>
      <p:sp>
        <p:nvSpPr>
          <p:cNvPr id="16" name="TextBox 15"/>
          <p:cNvSpPr txBox="1"/>
          <p:nvPr/>
        </p:nvSpPr>
        <p:spPr>
          <a:xfrm>
            <a:off x="5181600" y="312886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41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74</a:t>
            </a:r>
            <a:endParaRPr lang="en-US" sz="800" spc="-10" dirty="0"/>
          </a:p>
        </p:txBody>
      </p:sp>
      <p:sp>
        <p:nvSpPr>
          <p:cNvPr id="17" name="TextBox 16"/>
          <p:cNvSpPr txBox="1"/>
          <p:nvPr/>
        </p:nvSpPr>
        <p:spPr>
          <a:xfrm>
            <a:off x="5181600" y="338840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14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4</a:t>
            </a:r>
            <a:r>
              <a:rPr lang="en-US" altLang="zh-CN" sz="800" spc="-10" dirty="0" smtClean="0"/>
              <a:t>.79</a:t>
            </a:r>
            <a:endParaRPr lang="en-US" sz="800" spc="-10" dirty="0"/>
          </a:p>
        </p:txBody>
      </p:sp>
      <p:sp>
        <p:nvSpPr>
          <p:cNvPr id="18" name="TextBox 17"/>
          <p:cNvSpPr txBox="1"/>
          <p:nvPr/>
        </p:nvSpPr>
        <p:spPr>
          <a:xfrm>
            <a:off x="5181600" y="364795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altLang="zh-CN" sz="800" spc="-10" dirty="0" smtClean="0"/>
              <a:t>6.28</a:t>
            </a:r>
          </a:p>
          <a:p>
            <a:pPr>
              <a:lnSpc>
                <a:spcPts val="600"/>
              </a:lnSpc>
            </a:pPr>
            <a:r>
              <a:rPr lang="en-US" altLang="zh-CN" sz="800" spc="-10" dirty="0" smtClean="0"/>
              <a:t>6.41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181600" y="389961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64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29</a:t>
            </a:r>
            <a:endParaRPr lang="en-US" sz="800" spc="-10" dirty="0"/>
          </a:p>
        </p:txBody>
      </p:sp>
      <p:sp>
        <p:nvSpPr>
          <p:cNvPr id="20" name="TextBox 19"/>
          <p:cNvSpPr txBox="1"/>
          <p:nvPr/>
        </p:nvSpPr>
        <p:spPr>
          <a:xfrm>
            <a:off x="5181600" y="415915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34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62</a:t>
            </a:r>
            <a:endParaRPr lang="en-US" sz="800" spc="-10" dirty="0"/>
          </a:p>
        </p:txBody>
      </p:sp>
      <p:sp>
        <p:nvSpPr>
          <p:cNvPr id="21" name="TextBox 20"/>
          <p:cNvSpPr txBox="1"/>
          <p:nvPr/>
        </p:nvSpPr>
        <p:spPr>
          <a:xfrm>
            <a:off x="5181600" y="441870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77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1</a:t>
            </a:r>
            <a:r>
              <a:rPr lang="en-US" altLang="zh-CN" sz="800" spc="-10" dirty="0" smtClean="0"/>
              <a:t>.38</a:t>
            </a:r>
            <a:endParaRPr lang="en-US" sz="800" spc="-10" dirty="0"/>
          </a:p>
        </p:txBody>
      </p:sp>
      <p:sp>
        <p:nvSpPr>
          <p:cNvPr id="22" name="TextBox 21"/>
          <p:cNvSpPr txBox="1"/>
          <p:nvPr/>
        </p:nvSpPr>
        <p:spPr>
          <a:xfrm>
            <a:off x="5181600" y="467824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4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47</a:t>
            </a:r>
            <a:endParaRPr lang="en-US" sz="800" spc="-10" dirty="0"/>
          </a:p>
        </p:txBody>
      </p:sp>
      <p:sp>
        <p:nvSpPr>
          <p:cNvPr id="23" name="TextBox 22"/>
          <p:cNvSpPr txBox="1"/>
          <p:nvPr/>
        </p:nvSpPr>
        <p:spPr>
          <a:xfrm>
            <a:off x="5181600" y="493779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30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66</a:t>
            </a:r>
            <a:endParaRPr lang="en-US" sz="800" spc="-10" dirty="0"/>
          </a:p>
        </p:txBody>
      </p:sp>
      <p:sp>
        <p:nvSpPr>
          <p:cNvPr id="24" name="TextBox 23"/>
          <p:cNvSpPr txBox="1"/>
          <p:nvPr/>
        </p:nvSpPr>
        <p:spPr>
          <a:xfrm>
            <a:off x="5181600" y="519734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23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9</a:t>
            </a:r>
            <a:r>
              <a:rPr lang="en-US" altLang="zh-CN" sz="800" spc="-10" dirty="0" smtClean="0"/>
              <a:t>.70</a:t>
            </a:r>
            <a:endParaRPr lang="en-US" sz="800" spc="-10" dirty="0"/>
          </a:p>
        </p:txBody>
      </p:sp>
      <p:sp>
        <p:nvSpPr>
          <p:cNvPr id="25" name="TextBox 24"/>
          <p:cNvSpPr txBox="1"/>
          <p:nvPr/>
        </p:nvSpPr>
        <p:spPr>
          <a:xfrm>
            <a:off x="5181600" y="545688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33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35</a:t>
            </a:r>
            <a:endParaRPr lang="en-US" sz="800" spc="-10" dirty="0"/>
          </a:p>
        </p:txBody>
      </p:sp>
      <p:sp>
        <p:nvSpPr>
          <p:cNvPr id="26" name="TextBox 25"/>
          <p:cNvSpPr txBox="1"/>
          <p:nvPr/>
        </p:nvSpPr>
        <p:spPr>
          <a:xfrm>
            <a:off x="5181600" y="571643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47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3</a:t>
            </a:r>
            <a:r>
              <a:rPr lang="en-US" altLang="zh-CN" sz="800" spc="-10" dirty="0" smtClean="0"/>
              <a:t>.23</a:t>
            </a:r>
            <a:endParaRPr lang="en-US" sz="800" spc="-10" dirty="0"/>
          </a:p>
        </p:txBody>
      </p:sp>
      <p:sp>
        <p:nvSpPr>
          <p:cNvPr id="27" name="TextBox 26"/>
          <p:cNvSpPr txBox="1"/>
          <p:nvPr/>
        </p:nvSpPr>
        <p:spPr>
          <a:xfrm>
            <a:off x="5181600" y="597597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6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51</a:t>
            </a:r>
            <a:endParaRPr lang="en-US" sz="800" spc="-10" dirty="0"/>
          </a:p>
        </p:txBody>
      </p:sp>
      <p:sp>
        <p:nvSpPr>
          <p:cNvPr id="28" name="TextBox 27"/>
          <p:cNvSpPr txBox="1"/>
          <p:nvPr/>
        </p:nvSpPr>
        <p:spPr>
          <a:xfrm>
            <a:off x="5181600" y="623552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04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70</a:t>
            </a:r>
            <a:endParaRPr lang="en-US" sz="800" spc="-10" dirty="0"/>
          </a:p>
        </p:txBody>
      </p:sp>
      <p:sp>
        <p:nvSpPr>
          <p:cNvPr id="29" name="TextBox 28"/>
          <p:cNvSpPr txBox="1"/>
          <p:nvPr/>
        </p:nvSpPr>
        <p:spPr>
          <a:xfrm>
            <a:off x="5181600" y="649507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1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96</a:t>
            </a:r>
            <a:endParaRPr lang="en-US" sz="800" spc="-10" dirty="0"/>
          </a:p>
        </p:txBody>
      </p:sp>
      <p:sp>
        <p:nvSpPr>
          <p:cNvPr id="30" name="TextBox 29"/>
          <p:cNvSpPr txBox="1"/>
          <p:nvPr/>
        </p:nvSpPr>
        <p:spPr>
          <a:xfrm>
            <a:off x="5181600" y="675461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1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41</a:t>
            </a:r>
            <a:endParaRPr lang="en-US" sz="800" spc="-10" dirty="0"/>
          </a:p>
        </p:txBody>
      </p:sp>
      <p:sp>
        <p:nvSpPr>
          <p:cNvPr id="31" name="TextBox 30"/>
          <p:cNvSpPr txBox="1"/>
          <p:nvPr/>
        </p:nvSpPr>
        <p:spPr>
          <a:xfrm>
            <a:off x="5181600" y="701416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49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55</a:t>
            </a:r>
            <a:endParaRPr lang="en-US" sz="800" spc="-10" dirty="0"/>
          </a:p>
        </p:txBody>
      </p:sp>
      <p:sp>
        <p:nvSpPr>
          <p:cNvPr id="32" name="TextBox 31"/>
          <p:cNvSpPr txBox="1"/>
          <p:nvPr/>
        </p:nvSpPr>
        <p:spPr>
          <a:xfrm>
            <a:off x="5181600" y="727370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00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62</a:t>
            </a:r>
            <a:endParaRPr lang="en-US" sz="800" spc="-10" dirty="0"/>
          </a:p>
        </p:txBody>
      </p:sp>
      <p:sp>
        <p:nvSpPr>
          <p:cNvPr id="33" name="TextBox 32"/>
          <p:cNvSpPr txBox="1"/>
          <p:nvPr/>
        </p:nvSpPr>
        <p:spPr>
          <a:xfrm>
            <a:off x="5181600" y="753325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0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97</a:t>
            </a:r>
            <a:endParaRPr lang="en-US" sz="800" spc="-10" dirty="0"/>
          </a:p>
        </p:txBody>
      </p:sp>
      <p:sp>
        <p:nvSpPr>
          <p:cNvPr id="34" name="TextBox 33"/>
          <p:cNvSpPr txBox="1"/>
          <p:nvPr/>
        </p:nvSpPr>
        <p:spPr>
          <a:xfrm>
            <a:off x="5181600" y="779280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59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90</a:t>
            </a:r>
            <a:endParaRPr lang="en-US" sz="800" spc="-10" dirty="0"/>
          </a:p>
        </p:txBody>
      </p:sp>
      <p:sp>
        <p:nvSpPr>
          <p:cNvPr id="35" name="TextBox 34"/>
          <p:cNvSpPr txBox="1"/>
          <p:nvPr/>
        </p:nvSpPr>
        <p:spPr>
          <a:xfrm>
            <a:off x="5181600" y="805235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32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1</a:t>
            </a:r>
            <a:r>
              <a:rPr lang="en-US" altLang="zh-CN" sz="800" spc="-10" dirty="0" smtClean="0"/>
              <a:t>.48</a:t>
            </a:r>
            <a:endParaRPr lang="en-US" sz="800" spc="-10" dirty="0"/>
          </a:p>
        </p:txBody>
      </p:sp>
      <p:sp>
        <p:nvSpPr>
          <p:cNvPr id="36" name="TextBox 35"/>
          <p:cNvSpPr txBox="1"/>
          <p:nvPr/>
        </p:nvSpPr>
        <p:spPr>
          <a:xfrm>
            <a:off x="5099374" y="105228"/>
            <a:ext cx="800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CV (%)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25171000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0</Words>
  <Application>Microsoft Office PowerPoint</Application>
  <PresentationFormat>On-screen Show (4:3)</PresentationFormat>
  <Paragraphs>6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NG</dc:creator>
  <cp:lastModifiedBy>PENG</cp:lastModifiedBy>
  <cp:revision>1</cp:revision>
  <dcterms:created xsi:type="dcterms:W3CDTF">2006-08-16T00:00:00Z</dcterms:created>
  <dcterms:modified xsi:type="dcterms:W3CDTF">2013-03-20T09:55:52Z</dcterms:modified>
</cp:coreProperties>
</file>